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654DB-091E-485F-B855-DBCDA8C488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DBFDF-6633-40EB-93B6-7309446883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CEB02-C661-408A-89D0-004815A928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0FC83-485A-45FF-9165-843D81A7C0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74B24-ECD7-423A-AEE1-9239C2F464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1F609-BA90-4F16-8E85-60DDA777B4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2D981-EF8E-4DA1-B7CC-0A330720F3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46AD3-0DC9-4A20-88A7-AF7CC9FEE4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E46B3-D4DF-48B4-AB37-B80E7DBC39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4F440-87D2-45E0-A842-AFBB8EDEDA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72AFDD-851F-462C-8E43-A987D93301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7334C-4443-4D45-A90F-B89F9915BC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6BB930-7205-4C14-BB5A-2497E5E0D7F6}" type="slidenum">
              <a:rPr b="0" lang="fi-FI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662760" y="1639800"/>
            <a:ext cx="543708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Database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SwissProt 2011 (531473 sequences; 188463640 residues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Taxonomy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Other Bacteria (42004 sequence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Protein hits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</a:t>
            </a:r>
            <a:r>
              <a:rPr b="1" lang="fi-FI" sz="1200" spc="-1" strike="noStrike" u="sng">
                <a:solidFill>
                  <a:srgbClr val="000000"/>
                </a:solidFill>
                <a:uFillTx/>
                <a:latin typeface="Calibri"/>
              </a:rPr>
              <a:t>P59915|HAGA1_PORGI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Hemagglutinin 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Origin Species=Porphyromonas gingivalis (strain ATCC BAA-308/W83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ene Name=hag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Mascot Score Histogram (Probability Based Mowse scor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765000" y="3081240"/>
            <a:ext cx="3672000" cy="1932120"/>
          </a:xfrm>
          <a:prstGeom prst="rect">
            <a:avLst/>
          </a:prstGeom>
          <a:ln w="0">
            <a:noFill/>
          </a:ln>
        </p:spPr>
      </p:pic>
      <p:sp>
        <p:nvSpPr>
          <p:cNvPr id="43" name="TextBox 6"/>
          <p:cNvSpPr/>
          <p:nvPr/>
        </p:nvSpPr>
        <p:spPr>
          <a:xfrm>
            <a:off x="305280" y="145728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2344320" y="3884760"/>
            <a:ext cx="193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Hemagglutinin A (score 30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5" name="Straight Arrow Connector 8"/>
          <p:cNvCxnSpPr/>
          <p:nvPr/>
        </p:nvCxnSpPr>
        <p:spPr>
          <a:xfrm>
            <a:off x="3993840" y="4184640"/>
            <a:ext cx="1080" cy="21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1"/>
          <p:cNvSpPr/>
          <p:nvPr/>
        </p:nvSpPr>
        <p:spPr>
          <a:xfrm>
            <a:off x="276480" y="27288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"/>
          <p:cNvSpPr/>
          <p:nvPr/>
        </p:nvSpPr>
        <p:spPr>
          <a:xfrm>
            <a:off x="588960" y="84924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773280" y="457200"/>
            <a:ext cx="5248080" cy="7219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" descr=""/>
          <p:cNvPicPr/>
          <p:nvPr/>
        </p:nvPicPr>
        <p:blipFill>
          <a:blip r:embed="rId1"/>
          <a:stretch/>
        </p:blipFill>
        <p:spPr>
          <a:xfrm>
            <a:off x="12600" y="250920"/>
            <a:ext cx="6858000" cy="4849560"/>
          </a:xfrm>
          <a:prstGeom prst="rect">
            <a:avLst/>
          </a:prstGeom>
          <a:ln w="0">
            <a:noFill/>
          </a:ln>
        </p:spPr>
      </p:pic>
      <p:sp>
        <p:nvSpPr>
          <p:cNvPr id="50" name="TextBox 1"/>
          <p:cNvSpPr/>
          <p:nvPr/>
        </p:nvSpPr>
        <p:spPr>
          <a:xfrm>
            <a:off x="276480" y="27288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5" descr=""/>
          <p:cNvPicPr/>
          <p:nvPr/>
        </p:nvPicPr>
        <p:blipFill>
          <a:blip r:embed="rId2"/>
          <a:stretch/>
        </p:blipFill>
        <p:spPr>
          <a:xfrm>
            <a:off x="25560" y="4952880"/>
            <a:ext cx="6858000" cy="4849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3T19:58:59Z</dcterms:created>
  <dc:creator>Windows User</dc:creator>
  <dc:description/>
  <dc:language>en-US</dc:language>
  <cp:lastModifiedBy>Windows User</cp:lastModifiedBy>
  <dcterms:modified xsi:type="dcterms:W3CDTF">2012-03-12T14:15:38Z</dcterms:modified>
  <cp:revision>6</cp:revision>
  <dc:subject/>
  <dc:title>PowerPoint Presentation</dc:title>
</cp:coreProperties>
</file>